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5143500" type="screen16x9"/>
  <p:notesSz cx="6858000" cy="9144000"/>
  <p:embeddedFontLst>
    <p:embeddedFont>
      <p:font typeface="Oxanium" pitchFamily="2" charset="77"/>
      <p:regular r:id="rId6"/>
      <p:bold r:id="rId7"/>
    </p:embeddedFont>
    <p:embeddedFont>
      <p:font typeface="Roboto" panose="02000000000000000000" pitchFamily="2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60" d="100"/>
          <a:sy n="160" d="100"/>
        </p:scale>
        <p:origin x="784" y="17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font" Target="fonts/font6.fntdata"/><Relationship Id="rId5" Type="http://schemas.openxmlformats.org/officeDocument/2006/relationships/notesMaster" Target="notesMasters/notesMaster1.xml"/><Relationship Id="rId15" Type="http://schemas.openxmlformats.org/officeDocument/2006/relationships/tableStyles" Target="tableStyles.xml"/><Relationship Id="rId10" Type="http://schemas.openxmlformats.org/officeDocument/2006/relationships/font" Target="fonts/font5.fntdata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g391f6b1bc00_0_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7" name="Google Shape;57;g391f6b1bc00_0_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Google Shape;64;g391f6b1bc00_0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5" name="Google Shape;65;g391f6b1bc00_0_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3072000" y="1218025"/>
            <a:ext cx="3000000" cy="2339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latin typeface="Oxanium"/>
                <a:ea typeface="Oxanium"/>
                <a:cs typeface="Oxanium"/>
                <a:sym typeface="Oxanium"/>
              </a:rPr>
              <a:t>Carbon9: Spence</a:t>
            </a:r>
            <a:endParaRPr b="1">
              <a:latin typeface="Oxanium"/>
              <a:ea typeface="Oxanium"/>
              <a:cs typeface="Oxanium"/>
              <a:sym typeface="Oxanium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i="1">
                <a:latin typeface="Oxanium"/>
                <a:ea typeface="Oxanium"/>
                <a:cs typeface="Oxanium"/>
                <a:sym typeface="Oxanium"/>
              </a:rPr>
              <a:t>Spence Hot Springs Expedition</a:t>
            </a:r>
            <a:endParaRPr i="1">
              <a:latin typeface="Oxanium"/>
              <a:ea typeface="Oxanium"/>
              <a:cs typeface="Oxanium"/>
              <a:sym typeface="Oxanium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latin typeface="Roboto"/>
                <a:ea typeface="Roboto"/>
                <a:cs typeface="Roboto"/>
                <a:sym typeface="Roboto"/>
              </a:rPr>
              <a:t>The Two Frontiers Project (2FP)</a:t>
            </a:r>
            <a:endParaRPr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latin typeface="Roboto"/>
                <a:ea typeface="Roboto"/>
                <a:cs typeface="Roboto"/>
                <a:sym typeface="Roboto"/>
              </a:rPr>
              <a:t>Carbon / Extreme Terrestrial Environments</a:t>
            </a:r>
            <a:endParaRPr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latin typeface="Roboto"/>
                <a:ea typeface="Roboto"/>
                <a:cs typeface="Roboto"/>
                <a:sym typeface="Roboto"/>
              </a:rPr>
              <a:t>Spence Hot Springs, Santa Fe National Forest, New Mexico</a:t>
            </a:r>
            <a:endParaRPr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b="1">
              <a:latin typeface="Oxanium"/>
              <a:ea typeface="Oxanium"/>
              <a:cs typeface="Oxanium"/>
              <a:sym typeface="Oxanium"/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latin typeface="Oxanium"/>
                <a:ea typeface="Oxanium"/>
                <a:cs typeface="Oxanium"/>
                <a:sym typeface="Oxanium"/>
              </a:rPr>
              <a:t>May 18–19, 2025</a:t>
            </a:r>
            <a:endParaRPr b="1">
              <a:latin typeface="Oxanium"/>
              <a:ea typeface="Oxanium"/>
              <a:cs typeface="Oxanium"/>
              <a:sym typeface="Oxanium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4"/>
          <p:cNvSpPr txBox="1"/>
          <p:nvPr/>
        </p:nvSpPr>
        <p:spPr>
          <a:xfrm>
            <a:off x="174929" y="682544"/>
            <a:ext cx="4608000" cy="2376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Purpose</a:t>
            </a:r>
            <a:br>
              <a:rPr lang="en" sz="1200" dirty="0">
                <a:latin typeface="Roboto"/>
                <a:ea typeface="Roboto"/>
                <a:cs typeface="Roboto"/>
                <a:sym typeface="Roboto"/>
              </a:rPr>
            </a:b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Characterize microbial communities associated with low-temperature geothermal hot springs in a temperate continental environment.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Why Spence Hot Springs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28575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9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Accessible geothermal site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28575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Visible microbial mats and mineral-rich sediments</a:t>
            </a:r>
            <a:br>
              <a:rPr lang="en" sz="1200" dirty="0">
                <a:latin typeface="Roboto"/>
                <a:ea typeface="Roboto"/>
                <a:cs typeface="Roboto"/>
                <a:sym typeface="Roboto"/>
              </a:rPr>
            </a:b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Representative of broader Valles Caldera geothermal system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62" name="Google Shape;62;p14"/>
          <p:cNvSpPr txBox="1"/>
          <p:nvPr/>
        </p:nvSpPr>
        <p:spPr>
          <a:xfrm>
            <a:off x="4572000" y="809765"/>
            <a:ext cx="4500300" cy="1477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Primary Objectives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2857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Collect microbial mat, sediment, and spring water sample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2857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Record standardized environmental metadata</a:t>
            </a:r>
            <a:br>
              <a:rPr lang="en" sz="1200" dirty="0">
                <a:latin typeface="Roboto"/>
                <a:ea typeface="Roboto"/>
                <a:cs typeface="Roboto"/>
                <a:sym typeface="Roboto"/>
              </a:rPr>
            </a:b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Generate baseline data for future geothermal sampling in the region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200" dirty="0">
              <a:latin typeface="Roboto"/>
              <a:ea typeface="Roboto"/>
              <a:cs typeface="Roboto"/>
              <a:sym typeface="Roboto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5"/>
          <p:cNvSpPr txBox="1"/>
          <p:nvPr/>
        </p:nvSpPr>
        <p:spPr>
          <a:xfrm>
            <a:off x="0" y="110050"/>
            <a:ext cx="4608000" cy="1797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None/>
            </a:pPr>
            <a:r>
              <a:rPr lang="en" sz="1200" b="1">
                <a:latin typeface="Roboto"/>
                <a:ea typeface="Roboto"/>
                <a:cs typeface="Roboto"/>
                <a:sym typeface="Roboto"/>
              </a:rPr>
              <a:t>Study Site: Spence Hot Springs</a:t>
            </a:r>
            <a:endParaRPr sz="1200" b="1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>
                <a:latin typeface="Roboto"/>
                <a:ea typeface="Roboto"/>
                <a:cs typeface="Roboto"/>
                <a:sym typeface="Roboto"/>
              </a:rPr>
              <a:t>Located along the Jemez River</a:t>
            </a:r>
            <a:endParaRPr sz="120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>
                <a:latin typeface="Roboto"/>
                <a:ea typeface="Roboto"/>
                <a:cs typeface="Roboto"/>
                <a:sym typeface="Roboto"/>
              </a:rPr>
              <a:t>Santa Fe National Forest, adjacent to Valles Caldera</a:t>
            </a:r>
            <a:endParaRPr sz="120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>
                <a:latin typeface="Roboto"/>
                <a:ea typeface="Roboto"/>
                <a:cs typeface="Roboto"/>
                <a:sym typeface="Roboto"/>
              </a:rPr>
              <a:t>Warm spring outflows</a:t>
            </a:r>
            <a:br>
              <a:rPr lang="en" sz="1200">
                <a:latin typeface="Roboto"/>
                <a:ea typeface="Roboto"/>
                <a:cs typeface="Roboto"/>
                <a:sym typeface="Roboto"/>
              </a:rPr>
            </a:br>
            <a:r>
              <a:rPr lang="en" sz="1200">
                <a:latin typeface="Roboto"/>
                <a:ea typeface="Roboto"/>
                <a:cs typeface="Roboto"/>
                <a:sym typeface="Roboto"/>
              </a:rPr>
              <a:t>Moderate water temperatures</a:t>
            </a:r>
            <a:endParaRPr sz="120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Char char="●"/>
            </a:pPr>
            <a:r>
              <a:rPr lang="en" sz="1200">
                <a:latin typeface="Roboto"/>
                <a:ea typeface="Roboto"/>
                <a:cs typeface="Roboto"/>
                <a:sym typeface="Roboto"/>
              </a:rPr>
              <a:t>Visible microbial mats and mineral deposits</a:t>
            </a:r>
            <a:br>
              <a:rPr lang="en" sz="1200" b="1">
                <a:latin typeface="Roboto"/>
                <a:ea typeface="Roboto"/>
                <a:cs typeface="Roboto"/>
                <a:sym typeface="Roboto"/>
              </a:rPr>
            </a:br>
            <a:endParaRPr sz="1200"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68" name="Google Shape;68;p15"/>
          <p:cNvSpPr txBox="1"/>
          <p:nvPr/>
        </p:nvSpPr>
        <p:spPr>
          <a:xfrm>
            <a:off x="372968" y="2043850"/>
            <a:ext cx="4321800" cy="22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Sampling Plan - Target Substrates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Surface microbial mats at spring outflow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Shallow sediments at pool margin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Spring water upstream and downstream of geothermal influence</a:t>
            </a:r>
            <a:br>
              <a:rPr lang="en" sz="1200" dirty="0">
                <a:latin typeface="Roboto"/>
                <a:ea typeface="Roboto"/>
                <a:cs typeface="Roboto"/>
                <a:sym typeface="Roboto"/>
              </a:rPr>
            </a:b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Metadata Collected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GPS coordinate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Water temperature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pH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Visual site observation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69" name="Google Shape;69;p15"/>
          <p:cNvSpPr txBox="1"/>
          <p:nvPr/>
        </p:nvSpPr>
        <p:spPr>
          <a:xfrm>
            <a:off x="4572000" y="245650"/>
            <a:ext cx="3946800" cy="166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Permitting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To be conducted in accordance with Santa Fe National Forest regulations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No permanent site alteration</a:t>
            </a:r>
            <a:br>
              <a:rPr lang="en" sz="1200" dirty="0">
                <a:latin typeface="Roboto"/>
                <a:ea typeface="Roboto"/>
                <a:cs typeface="Roboto"/>
                <a:sym typeface="Roboto"/>
              </a:rPr>
            </a:b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 b="1" dirty="0">
                <a:latin typeface="Roboto"/>
                <a:ea typeface="Roboto"/>
                <a:cs typeface="Roboto"/>
                <a:sym typeface="Roboto"/>
              </a:rPr>
              <a:t>Compliance</a:t>
            </a:r>
            <a:endParaRPr sz="1200" b="1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Non-invasive scientific sampling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  <a:p>
            <a:pPr marL="457200" lvl="0" indent="-3048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Roboto"/>
              <a:buChar char="●"/>
            </a:pPr>
            <a:r>
              <a:rPr lang="en" sz="1200" dirty="0">
                <a:latin typeface="Roboto"/>
                <a:ea typeface="Roboto"/>
                <a:cs typeface="Roboto"/>
                <a:sym typeface="Roboto"/>
              </a:rPr>
              <a:t>Institutional and safety requirements followed</a:t>
            </a:r>
            <a:endParaRPr sz="1200" dirty="0">
              <a:latin typeface="Roboto"/>
              <a:ea typeface="Roboto"/>
              <a:cs typeface="Roboto"/>
              <a:sym typeface="Roboto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4</Words>
  <Application>Microsoft Macintosh PowerPoint</Application>
  <PresentationFormat>On-screen Show (16:9)</PresentationFormat>
  <Paragraphs>3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Oxanium</vt:lpstr>
      <vt:lpstr>Arial</vt:lpstr>
      <vt:lpstr>Roboto</vt:lpstr>
      <vt:lpstr>Simple Ligh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Krista A Ryon</cp:lastModifiedBy>
  <cp:revision>1</cp:revision>
  <dcterms:modified xsi:type="dcterms:W3CDTF">2025-12-25T15:07:50Z</dcterms:modified>
</cp:coreProperties>
</file>